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45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editar el estilo de subtítul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6AA89-9419-4F73-9088-0F8F7A541F71}" type="datetimeFigureOut">
              <a:rPr lang="es-ES" smtClean="0"/>
              <a:t>07/11/20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2CCF4C-002C-424F-A178-BF695035188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572226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6AA89-9419-4F73-9088-0F8F7A541F71}" type="datetimeFigureOut">
              <a:rPr lang="es-ES" smtClean="0"/>
              <a:t>07/11/20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2CCF4C-002C-424F-A178-BF695035188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179696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6AA89-9419-4F73-9088-0F8F7A541F71}" type="datetimeFigureOut">
              <a:rPr lang="es-ES" smtClean="0"/>
              <a:t>07/11/20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2CCF4C-002C-424F-A178-BF695035188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872666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6AA89-9419-4F73-9088-0F8F7A541F71}" type="datetimeFigureOut">
              <a:rPr lang="es-ES" smtClean="0"/>
              <a:t>07/11/20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2CCF4C-002C-424F-A178-BF695035188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85716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6AA89-9419-4F73-9088-0F8F7A541F71}" type="datetimeFigureOut">
              <a:rPr lang="es-ES" smtClean="0"/>
              <a:t>07/11/20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2CCF4C-002C-424F-A178-BF695035188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910711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6AA89-9419-4F73-9088-0F8F7A541F71}" type="datetimeFigureOut">
              <a:rPr lang="es-ES" smtClean="0"/>
              <a:t>07/11/2024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2CCF4C-002C-424F-A178-BF695035188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653487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6AA89-9419-4F73-9088-0F8F7A541F71}" type="datetimeFigureOut">
              <a:rPr lang="es-ES" smtClean="0"/>
              <a:t>07/11/2024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2CCF4C-002C-424F-A178-BF695035188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701655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6AA89-9419-4F73-9088-0F8F7A541F71}" type="datetimeFigureOut">
              <a:rPr lang="es-ES" smtClean="0"/>
              <a:t>07/11/2024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2CCF4C-002C-424F-A178-BF695035188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309118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6AA89-9419-4F73-9088-0F8F7A541F71}" type="datetimeFigureOut">
              <a:rPr lang="es-ES" smtClean="0"/>
              <a:t>07/11/2024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2CCF4C-002C-424F-A178-BF695035188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176711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6AA89-9419-4F73-9088-0F8F7A541F71}" type="datetimeFigureOut">
              <a:rPr lang="es-ES" smtClean="0"/>
              <a:t>07/11/2024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2CCF4C-002C-424F-A178-BF695035188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314707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6AA89-9419-4F73-9088-0F8F7A541F71}" type="datetimeFigureOut">
              <a:rPr lang="es-ES" smtClean="0"/>
              <a:t>07/11/2024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2CCF4C-002C-424F-A178-BF695035188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557022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66AA89-9419-4F73-9088-0F8F7A541F71}" type="datetimeFigureOut">
              <a:rPr lang="es-ES" smtClean="0"/>
              <a:t>07/11/20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2CCF4C-002C-424F-A178-BF695035188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32071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ángulo 6"/>
          <p:cNvSpPr/>
          <p:nvPr/>
        </p:nvSpPr>
        <p:spPr>
          <a:xfrm>
            <a:off x="3036498" y="5295016"/>
            <a:ext cx="6533015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plo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ATPCA using </a:t>
            </a:r>
            <a:r>
              <a:rPr lang="en-US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'Duke</a:t>
            </a:r>
            <a:r>
              <a:rPr lang="en-US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'</a:t>
            </a:r>
            <a:r>
              <a:rPr lang="en-US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lueberry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ults of gene expression 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TH23, PL8, PG, PME3, EXP4, GH5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mechanical properties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SBreaking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lopeS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splacementS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BWork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total decay, water loss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Los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maturation index (MI) as variables. The component loadings of the variables are indicated by black lines, while th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e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amples are represented by blue dots: [(1) freshly harvested; (2) 3 d Air, (3) 3 d 15% CO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(4) 3 d 20% CO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(5) 14 d Air, (6) 3 d 15% CO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11 d Air, (7) 3 d 20% CO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11 d Air, (8) 29 d Air, (9) 3 d 15% CO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26 d Air, (10) 3 d 20% CO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26 d Air]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" name="Imagen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49514" y="989785"/>
            <a:ext cx="5492972" cy="41883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5899957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2</TotalTime>
  <Words>172</Words>
  <Application>Microsoft Office PowerPoint</Application>
  <PresentationFormat>Panorámica</PresentationFormat>
  <Paragraphs>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IA TERESA SANCHEZ BALLESTA</dc:creator>
  <cp:lastModifiedBy>MARIA TERESA SANCHEZ BALLESTA</cp:lastModifiedBy>
  <cp:revision>8</cp:revision>
  <dcterms:created xsi:type="dcterms:W3CDTF">2024-10-17T13:52:51Z</dcterms:created>
  <dcterms:modified xsi:type="dcterms:W3CDTF">2024-11-07T12:44:54Z</dcterms:modified>
</cp:coreProperties>
</file>